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05613" cy="99393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29" autoAdjust="0"/>
    <p:restoredTop sz="94660"/>
  </p:normalViewPr>
  <p:slideViewPr>
    <p:cSldViewPr snapToGrid="0">
      <p:cViewPr varScale="1">
        <p:scale>
          <a:sx n="84" d="100"/>
          <a:sy n="84" d="100"/>
        </p:scale>
        <p:origin x="978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字幕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347B0-2533-4B80-A046-967E87A1EF80}" type="datetimeFigureOut">
              <a:rPr kumimoji="1" lang="ja-JP" altLang="en-US" smtClean="0"/>
              <a:t>2018/4/27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9A40B-F6EE-4883-9763-BAAE028BCF0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0386095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347B0-2533-4B80-A046-967E87A1EF80}" type="datetimeFigureOut">
              <a:rPr kumimoji="1" lang="ja-JP" altLang="en-US" smtClean="0"/>
              <a:t>2018/4/27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9A40B-F6EE-4883-9763-BAAE028BCF0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5540212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347B0-2533-4B80-A046-967E87A1EF80}" type="datetimeFigureOut">
              <a:rPr kumimoji="1" lang="ja-JP" altLang="en-US" smtClean="0"/>
              <a:t>2018/4/27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9A40B-F6EE-4883-9763-BAAE028BCF0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62219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347B0-2533-4B80-A046-967E87A1EF80}" type="datetimeFigureOut">
              <a:rPr kumimoji="1" lang="ja-JP" altLang="en-US" smtClean="0"/>
              <a:t>2018/4/27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9A40B-F6EE-4883-9763-BAAE028BCF0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7870877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347B0-2533-4B80-A046-967E87A1EF80}" type="datetimeFigureOut">
              <a:rPr kumimoji="1" lang="ja-JP" altLang="en-US" smtClean="0"/>
              <a:t>2018/4/27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9A40B-F6EE-4883-9763-BAAE028BCF0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5878741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347B0-2533-4B80-A046-967E87A1EF80}" type="datetimeFigureOut">
              <a:rPr kumimoji="1" lang="ja-JP" altLang="en-US" smtClean="0"/>
              <a:t>2018/4/27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9A40B-F6EE-4883-9763-BAAE028BCF0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6574832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347B0-2533-4B80-A046-967E87A1EF80}" type="datetimeFigureOut">
              <a:rPr kumimoji="1" lang="ja-JP" altLang="en-US" smtClean="0"/>
              <a:t>2018/4/27</a:t>
            </a:fld>
            <a:endParaRPr kumimoji="1" lang="ja-JP" alt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9A40B-F6EE-4883-9763-BAAE028BCF0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2462896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347B0-2533-4B80-A046-967E87A1EF80}" type="datetimeFigureOut">
              <a:rPr kumimoji="1" lang="ja-JP" altLang="en-US" smtClean="0"/>
              <a:t>2018/4/27</a:t>
            </a:fld>
            <a:endParaRPr kumimoji="1" lang="ja-JP" alt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9A40B-F6EE-4883-9763-BAAE028BCF0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410860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347B0-2533-4B80-A046-967E87A1EF80}" type="datetimeFigureOut">
              <a:rPr kumimoji="1" lang="ja-JP" altLang="en-US" smtClean="0"/>
              <a:t>2018/4/27</a:t>
            </a:fld>
            <a:endParaRPr kumimoji="1" lang="ja-JP" alt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9A40B-F6EE-4883-9763-BAAE028BCF0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2323836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347B0-2533-4B80-A046-967E87A1EF80}" type="datetimeFigureOut">
              <a:rPr kumimoji="1" lang="ja-JP" altLang="en-US" smtClean="0"/>
              <a:t>2018/4/27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9A40B-F6EE-4883-9763-BAAE028BCF0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1094057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dirty="0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347B0-2533-4B80-A046-967E87A1EF80}" type="datetimeFigureOut">
              <a:rPr kumimoji="1" lang="ja-JP" altLang="en-US" smtClean="0"/>
              <a:t>2018/4/27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9A40B-F6EE-4883-9763-BAAE028BCF0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7553811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2347B0-2533-4B80-A046-967E87A1EF80}" type="datetimeFigureOut">
              <a:rPr kumimoji="1" lang="ja-JP" altLang="en-US" smtClean="0"/>
              <a:t>2018/4/27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19A40B-F6EE-4883-9763-BAAE028BCF0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3489819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DAD46369-8431-4C06-A527-93C9BFB49CC9}"/>
              </a:ext>
            </a:extLst>
          </p:cNvPr>
          <p:cNvSpPr txBox="1"/>
          <p:nvPr/>
        </p:nvSpPr>
        <p:spPr>
          <a:xfrm>
            <a:off x="6290531" y="6595110"/>
            <a:ext cx="28763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dditional file 2 (Muraki and Hirota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611D8D36-754E-4F3D-81A5-1647FADD310D}"/>
              </a:ext>
            </a:extLst>
          </p:cNvPr>
          <p:cNvSpPr txBox="1"/>
          <p:nvPr/>
        </p:nvSpPr>
        <p:spPr>
          <a:xfrm>
            <a:off x="5341102" y="2197893"/>
            <a:ext cx="3210615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Additional file 2. MALDI-TOF mass-spectrometric analysis of hFasLECD-Avi conjugate in the m/z measurement range between 10,000 –300,000.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Representative peaks of the identified subunits were labeled with the m/z values and the names of possible components.  The measurement conditions are described in the text.   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14108B44-7FB3-4718-A2C3-1CF69ECD98C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2164" y="1937904"/>
            <a:ext cx="4921890" cy="298219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186606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1</TotalTime>
  <Words>60</Words>
  <Application>Microsoft Office PowerPoint</Application>
  <PresentationFormat>画面に合わせる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村木三智郎</dc:creator>
  <cp:lastModifiedBy>村木 三智郎</cp:lastModifiedBy>
  <cp:revision>36</cp:revision>
  <cp:lastPrinted>2018-03-26T05:57:23Z</cp:lastPrinted>
  <dcterms:created xsi:type="dcterms:W3CDTF">2018-03-26T02:22:14Z</dcterms:created>
  <dcterms:modified xsi:type="dcterms:W3CDTF">2018-04-26T23:43:19Z</dcterms:modified>
</cp:coreProperties>
</file>